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1" r:id="rId2"/>
  </p:sldIdLst>
  <p:sldSz cx="12192000" cy="6858000"/>
  <p:notesSz cx="6950075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3CC33"/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FD0F851-EC5A-4D38-B0AD-8093EC10F338}" styleName="Light Style 1 - Accent 5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576" autoAdjust="0"/>
    <p:restoredTop sz="87900" autoAdjust="0"/>
  </p:normalViewPr>
  <p:slideViewPr>
    <p:cSldViewPr snapToGrid="0">
      <p:cViewPr varScale="1">
        <p:scale>
          <a:sx n="93" d="100"/>
          <a:sy n="93" d="100"/>
        </p:scale>
        <p:origin x="600" y="7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11699" cy="461804"/>
          </a:xfrm>
          <a:prstGeom prst="rect">
            <a:avLst/>
          </a:prstGeom>
        </p:spPr>
        <p:txBody>
          <a:bodyPr vert="horz" lIns="92492" tIns="46246" rIns="92492" bIns="46246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36768" y="0"/>
            <a:ext cx="3011699" cy="461804"/>
          </a:xfrm>
          <a:prstGeom prst="rect">
            <a:avLst/>
          </a:prstGeom>
        </p:spPr>
        <p:txBody>
          <a:bodyPr vert="horz" lIns="92492" tIns="46246" rIns="92492" bIns="46246" rtlCol="0"/>
          <a:lstStyle>
            <a:lvl1pPr algn="r">
              <a:defRPr sz="1200"/>
            </a:lvl1pPr>
          </a:lstStyle>
          <a:p>
            <a:fld id="{22A10592-44E5-47BA-9580-2B69EF601A15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95288" y="692150"/>
            <a:ext cx="6159500" cy="34639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92" tIns="46246" rIns="92492" bIns="46246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5008" y="4387136"/>
            <a:ext cx="5560060" cy="4156234"/>
          </a:xfrm>
          <a:prstGeom prst="rect">
            <a:avLst/>
          </a:prstGeom>
        </p:spPr>
        <p:txBody>
          <a:bodyPr vert="horz" lIns="92492" tIns="46246" rIns="92492" bIns="46246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772668"/>
            <a:ext cx="3011699" cy="461804"/>
          </a:xfrm>
          <a:prstGeom prst="rect">
            <a:avLst/>
          </a:prstGeom>
        </p:spPr>
        <p:txBody>
          <a:bodyPr vert="horz" lIns="92492" tIns="46246" rIns="92492" bIns="46246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36768" y="8772668"/>
            <a:ext cx="3011699" cy="461804"/>
          </a:xfrm>
          <a:prstGeom prst="rect">
            <a:avLst/>
          </a:prstGeom>
        </p:spPr>
        <p:txBody>
          <a:bodyPr vert="horz" lIns="92492" tIns="46246" rIns="92492" bIns="46246" rtlCol="0" anchor="b"/>
          <a:lstStyle>
            <a:lvl1pPr algn="r">
              <a:defRPr sz="1200"/>
            </a:lvl1pPr>
          </a:lstStyle>
          <a:p>
            <a:fld id="{5810CCB8-7A1C-425B-B257-F39C5E2DF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44398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dditional File 4: </a:t>
            </a:r>
            <a:r>
              <a:rPr lang="en-US" b="1" dirty="0"/>
              <a:t>Figure S2</a:t>
            </a:r>
            <a:r>
              <a:rPr lang="en-US" b="0" dirty="0"/>
              <a:t>. </a:t>
            </a: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xation processing did not aggregate the cells.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BMCs with greater than 2500 genes detected </a:t>
            </a:r>
            <a:r>
              <a:rPr lang="en-US" baseline="0" dirty="0"/>
              <a:t>(</a:t>
            </a:r>
            <a:r>
              <a:rPr lang="en-US" b="1" baseline="0" dirty="0"/>
              <a:t>a</a:t>
            </a:r>
            <a:r>
              <a:rPr lang="en-US" baseline="0" dirty="0"/>
              <a:t>)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r CD8+ cells with more than 2000 genes detected </a:t>
            </a:r>
            <a:r>
              <a:rPr lang="en-US" baseline="0" dirty="0"/>
              <a:t>(</a:t>
            </a:r>
            <a:r>
              <a:rPr lang="en-US" b="1" baseline="0" dirty="0"/>
              <a:t>b</a:t>
            </a:r>
            <a:r>
              <a:rPr lang="en-US" baseline="0" dirty="0"/>
              <a:t>)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ere flagged </a:t>
            </a: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ecause t</a:t>
            </a:r>
            <a:r>
              <a:rPr lang="en-US" baseline="0" dirty="0"/>
              <a:t>hese droplets usually contain more than one cell (doublet or </a:t>
            </a:r>
            <a:r>
              <a:rPr lang="en-US" baseline="0" dirty="0" err="1"/>
              <a:t>multiplet</a:t>
            </a:r>
            <a:r>
              <a:rPr lang="en-US" baseline="0" dirty="0"/>
              <a:t>). Fixation did not increase the rate of these GEMs/cells.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thanol-fixed PBMCs remained microscopically visible as single, intact round cells with the similar size as live ones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810CCB8-7A1C-425B-B257-F39C5E2DFB3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97636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28210E-A6BF-488F-9F9E-5439BD2AB50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EDEDF89-3B61-4354-A10A-EB97644B1DF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3DC900-999D-42D9-A130-36C5AC3E06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E9632-869D-4E0F-A76F-0304B5079128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2A0456-BFF8-462E-8ED4-43629CBC72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63464C-1D96-4A43-9E55-00DF3148DF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EF0BDF-4A58-4D2C-AEC0-BF321A785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73884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B721E2-959C-4F50-87D3-4D623DD9D7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F64F0D5-F2B8-4C93-B868-193D72C939E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34B0DF-850E-4020-B5E4-F95EE26D43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E9632-869D-4E0F-A76F-0304B5079128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743E41-FCA1-4FEA-BEB0-74399EB969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F4C7F1-CE3C-4E45-ABCF-84DB1FBCC1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EF0BDF-4A58-4D2C-AEC0-BF321A785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41169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53C5F48-6B79-48E9-B619-B596350E806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4D6337C-BFCF-4BC2-9082-8E3E2597763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1910F6-BB73-4B5A-AB78-EFF1C4B5E5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E9632-869D-4E0F-A76F-0304B5079128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6C98EF-5BDB-4B54-BEEA-7036FC9EE3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93F9C2-7E28-44AD-85F9-80F77235B3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EF0BDF-4A58-4D2C-AEC0-BF321A785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17265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C701FF-FBD4-45DD-9419-0B127CFEC4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7A86234-FF32-4F14-B290-B4794004943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330177-3FD8-49DF-8907-0A5413DE7F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E9632-869D-4E0F-A76F-0304B5079128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724D51-8568-4984-BE2B-27EE2438A1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5FF8AA-5F14-4214-88BA-3204402819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EF0BDF-4A58-4D2C-AEC0-BF321A785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17436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92DC2F-8B3B-47BD-860E-573CFF1A42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314767A-7B51-455B-AD87-0D8D56D5CB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55C319-A1BF-47AA-AE22-27788C930F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E9632-869D-4E0F-A76F-0304B5079128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2920CE-4E82-4F2D-87B1-39EF8C1620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56CAC2-F0EE-4882-8EAB-A1A2A36010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EF0BDF-4A58-4D2C-AEC0-BF321A785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33759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2017C7-69C7-465A-922E-C75C0ED3E8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08BD35-7980-4F28-9B9C-38DF7A24FCD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C08D1E8-15BE-4A7E-8C6E-CE32972058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7130AED-08FC-4B5F-AFA1-43147ABF45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E9632-869D-4E0F-A76F-0304B5079128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9F93642-8BD1-410D-86B3-BA2CBE3B08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943E619-3415-47EA-9520-AA5DA95021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EF0BDF-4A58-4D2C-AEC0-BF321A785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87521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F8DCA5-23B4-45DF-986F-465D09FE5B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A368875-F10A-4AFC-AF3A-B6F3C15518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F75383F-D594-4C77-95AC-E853F0EA6B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0C21B08-EE1F-4DAD-A33B-3FD558BB8C4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7D48FF5-8B0C-4A5C-BF4F-ACDE279B45B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79F5D03-41A9-4F1E-8BF0-E1461DF16F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E9632-869D-4E0F-A76F-0304B5079128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6AC5392-590A-4D49-B229-283F68E6D2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800E14E-0AB3-47FD-94B5-4D29D8BF5F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EF0BDF-4A58-4D2C-AEC0-BF321A785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13918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D498A7-A407-46CA-BD75-B0EC64AF46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1254BEB-F7AC-41C6-B5B6-D7691E9EFE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E9632-869D-4E0F-A76F-0304B5079128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7C5EB91-E3A1-45CD-96B5-4E5A669515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0A92F94-4CBB-4D16-A4FB-8BFBFC002B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EF0BDF-4A58-4D2C-AEC0-BF321A785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28860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357A6CE-7613-454D-9CA0-C33B5083A7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E9632-869D-4E0F-A76F-0304B5079128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4CCA41D-6A16-456A-B40F-9F915A7ECF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B7696F3-F528-40C6-A5CB-98FEF69FD0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EF0BDF-4A58-4D2C-AEC0-BF321A785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94699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46FC7D-F347-4378-8009-140577AB1A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90191A3-A012-444A-B70E-954AAE0B60B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2E328BF-853F-41B8-89FB-5AABE9CB37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BF64BDD-D5D3-4809-8464-2BF64F7C93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E9632-869D-4E0F-A76F-0304B5079128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2B39810-A4E2-4379-BABF-04523E2EF9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EEF0FC4-994F-49C0-BD10-3269B0FC1D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EF0BDF-4A58-4D2C-AEC0-BF321A785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20271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96EB2E-181B-4C1F-99EA-0405D51EDA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4A40846-E24C-4FA1-8AC5-4B1E5C59B4B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16A3780-7DB7-46EB-A11D-5569C741D0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BEDC694-B750-43E1-9704-3F9A4C9F88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E9632-869D-4E0F-A76F-0304B5079128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AE67ED4-265F-4EDB-9CED-ADF310B790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8924DAE-6100-427B-B3D5-CC07673477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EF0BDF-4A58-4D2C-AEC0-BF321A785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45447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EB5440B-A00E-4516-82E4-F9FD6EA958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92487D8-6FF6-49B6-BB63-1270BE79CB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F71965-BE6B-4381-8BBB-E993A4F43A8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4E9632-869D-4E0F-A76F-0304B5079128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5E0914-642D-48BD-90FB-CDA007EC029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9BCB20-D03A-477B-B627-26F7A6C10E0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EF0BDF-4A58-4D2C-AEC0-BF321A785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04786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05" t="18345" r="35139" b="23889"/>
          <a:stretch/>
        </p:blipFill>
        <p:spPr bwMode="auto">
          <a:xfrm>
            <a:off x="1392864" y="1364340"/>
            <a:ext cx="4786375" cy="26144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56" t="46424" r="36288" b="20058"/>
          <a:stretch/>
        </p:blipFill>
        <p:spPr bwMode="auto">
          <a:xfrm>
            <a:off x="6613451" y="1423499"/>
            <a:ext cx="4635794" cy="25102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2519825" y="961834"/>
            <a:ext cx="9541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srgbClr val="FF0000"/>
                </a:solidFill>
              </a:rPr>
              <a:t>PBMC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44165" y="2440745"/>
            <a:ext cx="6883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Live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35871" y="4815377"/>
            <a:ext cx="904917" cy="6771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Fixed</a:t>
            </a:r>
          </a:p>
          <a:p>
            <a:r>
              <a:rPr lang="en-US" sz="1400" b="1" dirty="0"/>
              <a:t>(3weekS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206925" y="1690180"/>
            <a:ext cx="7585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.75%</a:t>
            </a:r>
          </a:p>
        </p:txBody>
      </p:sp>
      <p:pic>
        <p:nvPicPr>
          <p:cNvPr id="9" name="Picture 2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26" t="23031" r="35767" b="20144"/>
          <a:stretch/>
        </p:blipFill>
        <p:spPr bwMode="auto">
          <a:xfrm>
            <a:off x="1384574" y="4284580"/>
            <a:ext cx="4794666" cy="225576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4206924" y="4551010"/>
            <a:ext cx="7585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.60%</a:t>
            </a:r>
          </a:p>
        </p:txBody>
      </p:sp>
      <p:pic>
        <p:nvPicPr>
          <p:cNvPr id="11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06" t="22799" r="35031" b="20391"/>
          <a:stretch/>
        </p:blipFill>
        <p:spPr bwMode="auto">
          <a:xfrm>
            <a:off x="6553781" y="4190186"/>
            <a:ext cx="4755134" cy="23392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9423771" y="4527381"/>
            <a:ext cx="7585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.50%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8079833" y="902675"/>
            <a:ext cx="85151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srgbClr val="FF0000"/>
                </a:solidFill>
              </a:rPr>
              <a:t>CD8+</a:t>
            </a:r>
          </a:p>
        </p:txBody>
      </p:sp>
      <p:cxnSp>
        <p:nvCxnSpPr>
          <p:cNvPr id="16" name="Straight Connector 15"/>
          <p:cNvCxnSpPr/>
          <p:nvPr/>
        </p:nvCxnSpPr>
        <p:spPr>
          <a:xfrm>
            <a:off x="4312693" y="3357349"/>
            <a:ext cx="1405719" cy="13648"/>
          </a:xfrm>
          <a:prstGeom prst="line">
            <a:avLst/>
          </a:prstGeom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4128573" y="3832722"/>
            <a:ext cx="14045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Medium: 1174</a:t>
            </a:r>
          </a:p>
        </p:txBody>
      </p:sp>
      <p:cxnSp>
        <p:nvCxnSpPr>
          <p:cNvPr id="20" name="Straight Connector 19"/>
          <p:cNvCxnSpPr/>
          <p:nvPr/>
        </p:nvCxnSpPr>
        <p:spPr>
          <a:xfrm>
            <a:off x="9717357" y="6193820"/>
            <a:ext cx="951395" cy="0"/>
          </a:xfrm>
          <a:prstGeom prst="line">
            <a:avLst/>
          </a:prstGeom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9490196" y="3330053"/>
            <a:ext cx="1405719" cy="13648"/>
          </a:xfrm>
          <a:prstGeom prst="line">
            <a:avLst/>
          </a:prstGeom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 flipV="1">
            <a:off x="4516226" y="6171063"/>
            <a:ext cx="1024765" cy="2422"/>
          </a:xfrm>
          <a:prstGeom prst="line">
            <a:avLst/>
          </a:prstGeom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4245593" y="6488668"/>
            <a:ext cx="13003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Medium: 944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9547847" y="6499418"/>
            <a:ext cx="13003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Medium: 831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9429676" y="3832722"/>
            <a:ext cx="13003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Medium: 981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44165" y="548857"/>
            <a:ext cx="17152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Figure S2.  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59982EB-2C41-45F8-8FE7-89CCE438CA6F}"/>
              </a:ext>
            </a:extLst>
          </p:cNvPr>
          <p:cNvSpPr txBox="1"/>
          <p:nvPr/>
        </p:nvSpPr>
        <p:spPr>
          <a:xfrm>
            <a:off x="6162711" y="679438"/>
            <a:ext cx="34977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b</a:t>
            </a:r>
          </a:p>
        </p:txBody>
      </p:sp>
      <p:sp>
        <p:nvSpPr>
          <p:cNvPr id="2" name="TextBox 1"/>
          <p:cNvSpPr txBox="1"/>
          <p:nvPr/>
        </p:nvSpPr>
        <p:spPr>
          <a:xfrm rot="10800000">
            <a:off x="1079774" y="2278949"/>
            <a:ext cx="430887" cy="588879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sz="1600" dirty="0"/>
              <a:t>Reads</a:t>
            </a:r>
          </a:p>
        </p:txBody>
      </p:sp>
      <p:sp>
        <p:nvSpPr>
          <p:cNvPr id="25" name="TextBox 24"/>
          <p:cNvSpPr txBox="1"/>
          <p:nvPr/>
        </p:nvSpPr>
        <p:spPr>
          <a:xfrm rot="10800000">
            <a:off x="6245843" y="2309180"/>
            <a:ext cx="400110" cy="528414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sz="1400" dirty="0"/>
              <a:t>Reads</a:t>
            </a:r>
          </a:p>
        </p:txBody>
      </p:sp>
      <p:sp>
        <p:nvSpPr>
          <p:cNvPr id="29" name="TextBox 28"/>
          <p:cNvSpPr txBox="1"/>
          <p:nvPr/>
        </p:nvSpPr>
        <p:spPr>
          <a:xfrm rot="10800000">
            <a:off x="6245844" y="5071632"/>
            <a:ext cx="400110" cy="528414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sz="1400" dirty="0"/>
              <a:t>Reads</a:t>
            </a:r>
          </a:p>
        </p:txBody>
      </p:sp>
      <p:sp>
        <p:nvSpPr>
          <p:cNvPr id="30" name="TextBox 29"/>
          <p:cNvSpPr txBox="1"/>
          <p:nvPr/>
        </p:nvSpPr>
        <p:spPr>
          <a:xfrm rot="10800000">
            <a:off x="1079773" y="5166313"/>
            <a:ext cx="430887" cy="588879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sz="1600" dirty="0"/>
              <a:t>Reads</a:t>
            </a:r>
          </a:p>
        </p:txBody>
      </p:sp>
      <p:sp>
        <p:nvSpPr>
          <p:cNvPr id="15" name="TextBox 14"/>
          <p:cNvSpPr txBox="1"/>
          <p:nvPr/>
        </p:nvSpPr>
        <p:spPr>
          <a:xfrm rot="10800000">
            <a:off x="3636201" y="2142782"/>
            <a:ext cx="400110" cy="1227387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sz="1400" dirty="0"/>
              <a:t>Detected genes</a:t>
            </a:r>
          </a:p>
        </p:txBody>
      </p:sp>
      <p:sp>
        <p:nvSpPr>
          <p:cNvPr id="32" name="TextBox 31"/>
          <p:cNvSpPr txBox="1"/>
          <p:nvPr/>
        </p:nvSpPr>
        <p:spPr>
          <a:xfrm rot="10800000">
            <a:off x="3692504" y="4815377"/>
            <a:ext cx="400110" cy="1227387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sz="1400" dirty="0"/>
              <a:t>Detected genes</a:t>
            </a:r>
          </a:p>
        </p:txBody>
      </p:sp>
      <p:sp>
        <p:nvSpPr>
          <p:cNvPr id="33" name="TextBox 32"/>
          <p:cNvSpPr txBox="1"/>
          <p:nvPr/>
        </p:nvSpPr>
        <p:spPr>
          <a:xfrm rot="10800000">
            <a:off x="8790962" y="4722146"/>
            <a:ext cx="400110" cy="1227387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sz="1400" dirty="0"/>
              <a:t>Detected genes</a:t>
            </a:r>
          </a:p>
        </p:txBody>
      </p:sp>
      <p:sp>
        <p:nvSpPr>
          <p:cNvPr id="34" name="TextBox 33"/>
          <p:cNvSpPr txBox="1"/>
          <p:nvPr/>
        </p:nvSpPr>
        <p:spPr>
          <a:xfrm rot="10800000">
            <a:off x="8790962" y="2164356"/>
            <a:ext cx="400110" cy="1227387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sz="1400" dirty="0"/>
              <a:t>Detected genes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9321313" y="1674328"/>
            <a:ext cx="7585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.81%</a:t>
            </a:r>
          </a:p>
        </p:txBody>
      </p:sp>
    </p:spTree>
    <p:extLst>
      <p:ext uri="{BB962C8B-B14F-4D97-AF65-F5344CB8AC3E}">
        <p14:creationId xmlns:p14="http://schemas.microsoft.com/office/powerpoint/2010/main" val="24911729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40</TotalTime>
  <Words>131</Words>
  <Application>Microsoft Office PowerPoint</Application>
  <PresentationFormat>Widescreen</PresentationFormat>
  <Paragraphs>2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en, Jinguo (NIH/NHLBI) [E]</dc:creator>
  <cp:lastModifiedBy>Chen, Jinguo (NIH/NIAID) [E]</cp:lastModifiedBy>
  <cp:revision>346</cp:revision>
  <cp:lastPrinted>2017-12-12T19:15:44Z</cp:lastPrinted>
  <dcterms:created xsi:type="dcterms:W3CDTF">2017-10-23T18:57:37Z</dcterms:created>
  <dcterms:modified xsi:type="dcterms:W3CDTF">2018-05-09T13:12:56Z</dcterms:modified>
</cp:coreProperties>
</file>